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F0E631-00F6-4C48-BEDE-375501F4CB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C907C0-6B2B-4128-8BA6-43316A0942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22F24C-04F9-4B14-83DC-B1B5BDB76CB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1AB6F3-E54C-46AB-A363-E339C940680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22E405-34FE-4B1B-8B31-442250CC1B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BA6B47-E58B-4663-B6D5-7407675919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280C9D-692A-4101-BDCA-FBA05E6CF2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0034D5-977B-46C1-9B61-067BBAE85C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30D8CA-C29D-4FB0-B086-ECD452347C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CBE79B-7A7D-4BB9-B84D-2B78415EC1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59476C-429D-4D99-9836-26C3D4BC24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499E70-2F93-44A8-965C-D677F3FC9D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6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6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6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32A2446-1CFD-4530-BBEF-4E75AFF337D1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12 Grupo"/>
          <p:cNvGrpSpPr/>
          <p:nvPr/>
        </p:nvGrpSpPr>
        <p:grpSpPr>
          <a:xfrm>
            <a:off x="1219320" y="1103400"/>
            <a:ext cx="4222440" cy="3531960"/>
            <a:chOff x="1219320" y="1103400"/>
            <a:chExt cx="4222440" cy="3531960"/>
          </a:xfrm>
        </p:grpSpPr>
        <p:grpSp>
          <p:nvGrpSpPr>
            <p:cNvPr id="42" name="Group 25"/>
            <p:cNvGrpSpPr/>
            <p:nvPr/>
          </p:nvGrpSpPr>
          <p:grpSpPr>
            <a:xfrm>
              <a:off x="1241280" y="1103400"/>
              <a:ext cx="4200480" cy="2149920"/>
              <a:chOff x="1241280" y="1103400"/>
              <a:chExt cx="4200480" cy="2149920"/>
            </a:xfrm>
          </p:grpSpPr>
          <p:sp>
            <p:nvSpPr>
              <p:cNvPr id="43" name="Text Box 5"/>
              <p:cNvSpPr/>
              <p:nvPr/>
            </p:nvSpPr>
            <p:spPr>
              <a:xfrm>
                <a:off x="1633680" y="1302840"/>
                <a:ext cx="3693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_tradnl" sz="8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0" lang="es-ES_tradnl" sz="800" spc="-1" strike="noStrike">
                    <a:solidFill>
                      <a:srgbClr val="000000"/>
                    </a:solidFill>
                    <a:latin typeface="Arial"/>
                  </a:rPr>
                  <a:t>1Kb   1     2    3    4     5    6    7    8    9   10  11   12   13  14   15   16  C-  C+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Line 6"/>
              <p:cNvSpPr/>
              <p:nvPr/>
            </p:nvSpPr>
            <p:spPr>
              <a:xfrm>
                <a:off x="2031840" y="1296720"/>
                <a:ext cx="2914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Text Box 7"/>
              <p:cNvSpPr/>
              <p:nvPr/>
            </p:nvSpPr>
            <p:spPr>
              <a:xfrm>
                <a:off x="3053880" y="1103400"/>
                <a:ext cx="695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2 progeny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Line 10"/>
              <p:cNvSpPr/>
              <p:nvPr/>
            </p:nvSpPr>
            <p:spPr>
              <a:xfrm>
                <a:off x="1672920" y="233784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Text Box 11"/>
              <p:cNvSpPr/>
              <p:nvPr/>
            </p:nvSpPr>
            <p:spPr>
              <a:xfrm>
                <a:off x="1241280" y="2242800"/>
                <a:ext cx="49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_tradnl" sz="800" spc="-1" strike="noStrike">
                    <a:solidFill>
                      <a:srgbClr val="000000"/>
                    </a:solidFill>
                    <a:latin typeface="Arial"/>
                  </a:rPr>
                  <a:t>762 bp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48" name="Picture 15" descr="30-10-08 cheq plasmid nptII"/>
              <p:cNvPicPr/>
              <p:nvPr/>
            </p:nvPicPr>
            <p:blipFill>
              <a:blip r:embed="rId1">
                <a:lum bright="6000"/>
              </a:blip>
              <a:srcRect l="0" t="14628" r="4691" b="5002"/>
              <a:stretch/>
            </p:blipFill>
            <p:spPr>
              <a:xfrm>
                <a:off x="1746000" y="1469520"/>
                <a:ext cx="3581280" cy="1342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9" name="AutoShape 19"/>
              <p:cNvSpPr/>
              <p:nvPr/>
            </p:nvSpPr>
            <p:spPr>
              <a:xfrm rot="16200000">
                <a:off x="2993760" y="1829520"/>
                <a:ext cx="104400" cy="2124360"/>
              </a:xfrm>
              <a:custGeom>
                <a:avLst/>
                <a:gdLst>
                  <a:gd name="textAreaLeft" fmla="*/ 66600 w 104400"/>
                  <a:gd name="textAreaRight" fmla="*/ 104760 w 104400"/>
                  <a:gd name="textAreaTop" fmla="*/ 55080 h 2124360"/>
                  <a:gd name="textAreaBottom" fmla="*/ 2069280 h 21243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6200" y="0"/>
                      <a:pt x="10800" y="900"/>
                      <a:pt x="10800" y="1800"/>
                    </a:cubicBezTo>
                    <a:lnTo>
                      <a:pt x="10800" y="9000"/>
                    </a:lnTo>
                    <a:cubicBezTo>
                      <a:pt x="10800" y="9900"/>
                      <a:pt x="5400" y="10800"/>
                      <a:pt x="0" y="10800"/>
                    </a:cubicBezTo>
                    <a:cubicBezTo>
                      <a:pt x="5400" y="10800"/>
                      <a:pt x="10800" y="11700"/>
                      <a:pt x="10800" y="12600"/>
                    </a:cubicBezTo>
                    <a:lnTo>
                      <a:pt x="10800" y="19800"/>
                    </a:lnTo>
                    <a:cubicBezTo>
                      <a:pt x="10800" y="20700"/>
                      <a:pt x="162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_tradnl" sz="18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AutoShape 20"/>
              <p:cNvSpPr/>
              <p:nvPr/>
            </p:nvSpPr>
            <p:spPr>
              <a:xfrm rot="16200000">
                <a:off x="4469400" y="2506680"/>
                <a:ext cx="96480" cy="762120"/>
              </a:xfrm>
              <a:custGeom>
                <a:avLst/>
                <a:gdLst>
                  <a:gd name="textAreaLeft" fmla="*/ 61560 w 96480"/>
                  <a:gd name="textAreaRight" fmla="*/ 96840 w 96480"/>
                  <a:gd name="textAreaTop" fmla="*/ 19800 h 762120"/>
                  <a:gd name="textAreaBottom" fmla="*/ 742320 h 7621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6200" y="0"/>
                      <a:pt x="10800" y="900"/>
                      <a:pt x="10800" y="1800"/>
                    </a:cubicBezTo>
                    <a:lnTo>
                      <a:pt x="10800" y="9000"/>
                    </a:lnTo>
                    <a:cubicBezTo>
                      <a:pt x="10800" y="9900"/>
                      <a:pt x="5400" y="10800"/>
                      <a:pt x="0" y="10800"/>
                    </a:cubicBezTo>
                    <a:cubicBezTo>
                      <a:pt x="5400" y="10800"/>
                      <a:pt x="10800" y="11700"/>
                      <a:pt x="10800" y="12600"/>
                    </a:cubicBezTo>
                    <a:lnTo>
                      <a:pt x="10800" y="19800"/>
                    </a:lnTo>
                    <a:cubicBezTo>
                      <a:pt x="10800" y="20700"/>
                      <a:pt x="162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_tradnl" sz="18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Text Box 21"/>
              <p:cNvSpPr/>
              <p:nvPr/>
            </p:nvSpPr>
            <p:spPr>
              <a:xfrm>
                <a:off x="2622240" y="2916000"/>
                <a:ext cx="28195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s-ES_tradnl" sz="800" spc="-1" strike="noStrike">
                    <a:solidFill>
                      <a:srgbClr val="000000"/>
                    </a:solidFill>
                    <a:latin typeface="Arial"/>
                  </a:rPr>
                  <a:t>Alq </a:t>
                </a:r>
                <a:r>
                  <a:rPr b="0" lang="es-ES_tradnl" sz="800" spc="-1" strike="noStrike">
                    <a:solidFill>
                      <a:srgbClr val="000000"/>
                    </a:solidFill>
                    <a:latin typeface="Arial"/>
                  </a:rPr>
                  <a:t>mutant plants</a:t>
                </a:r>
                <a:r>
                  <a:rPr b="0" i="1" lang="es-ES_tradnl" sz="800" spc="-1" strike="noStrike">
                    <a:solidFill>
                      <a:srgbClr val="000000"/>
                    </a:solidFill>
                    <a:latin typeface="Arial"/>
                  </a:rPr>
                  <a:t>                             </a:t>
                </a:r>
                <a:r>
                  <a:rPr b="0" lang="es-ES_tradnl" sz="800" spc="-1" strike="noStrike">
                    <a:solidFill>
                      <a:srgbClr val="000000"/>
                    </a:solidFill>
                    <a:latin typeface="Arial"/>
                  </a:rPr>
                  <a:t>WT plants </a:t>
                </a:r>
                <a:r>
                  <a:rPr b="0" i="1" lang="es-ES_tradnl" sz="800" spc="-1" strike="noStrike">
                    <a:solidFill>
                      <a:srgbClr val="000000"/>
                    </a:solidFill>
                    <a:latin typeface="Arial"/>
                  </a:rPr>
                  <a:t>                    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2" name="Text Box 26"/>
            <p:cNvSpPr/>
            <p:nvPr/>
          </p:nvSpPr>
          <p:spPr>
            <a:xfrm>
              <a:off x="1219320" y="3263760"/>
              <a:ext cx="4204080" cy="1371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Figure S1. The T-DNA insertion cosegregates with the 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lq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 mutant phenotype.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 Conventional PCR was performed using specific primers of the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</a:rPr>
                <a:t>nptII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 gene (</a:t>
              </a:r>
              <a:r>
                <a:rPr b="0" lang="es-E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– gcaggttctccggccgcttgg and R-ccttctatcgccttcttgacgag)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. Lines 1-12 correspond to plants showing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</a:rPr>
                <a:t>Alq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 mutant phenotype whereas the remaining T2 progeny plants (lines 13-16) showed wild-type (WT) phenotype. C+ and C- represent positive and negative controls.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8T19:34:00Z</dcterms:created>
  <dc:creator>Estela</dc:creator>
  <dc:description/>
  <dc:language>en-US</dc:language>
  <cp:lastModifiedBy>RLOZANO</cp:lastModifiedBy>
  <dcterms:modified xsi:type="dcterms:W3CDTF">2010-02-10T20:48:19Z</dcterms:modified>
  <cp:revision>75</cp:revision>
  <dc:subject/>
  <dc:title>Diapositiva 1</dc:title>
</cp:coreProperties>
</file>